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8" r:id="rId3"/>
    <p:sldId id="279" r:id="rId4"/>
    <p:sldId id="280" r:id="rId5"/>
    <p:sldId id="281" r:id="rId6"/>
    <p:sldId id="282" r:id="rId7"/>
    <p:sldId id="283" r:id="rId8"/>
    <p:sldId id="284" r:id="rId9"/>
    <p:sldId id="285" r:id="rId10"/>
    <p:sldId id="286" r:id="rId11"/>
    <p:sldId id="287" r:id="rId12"/>
    <p:sldId id="288" r:id="rId13"/>
    <p:sldId id="289" r:id="rId14"/>
    <p:sldId id="290" r:id="rId15"/>
    <p:sldId id="291" r:id="rId16"/>
    <p:sldId id="292" r:id="rId17"/>
    <p:sldId id="293" r:id="rId18"/>
    <p:sldId id="294" r:id="rId19"/>
    <p:sldId id="295" r:id="rId20"/>
    <p:sldId id="296" r:id="rId21"/>
    <p:sldId id="297" r:id="rId22"/>
    <p:sldId id="298" r:id="rId23"/>
    <p:sldId id="299" r:id="rId24"/>
    <p:sldId id="300" r:id="rId25"/>
    <p:sldId id="301" r:id="rId26"/>
    <p:sldId id="302" r:id="rId27"/>
    <p:sldId id="303" r:id="rId28"/>
    <p:sldId id="304" r:id="rId29"/>
    <p:sldId id="305" r:id="rId30"/>
    <p:sldId id="306" r:id="rId31"/>
    <p:sldId id="307" r:id="rId32"/>
    <p:sldId id="308" r:id="rId33"/>
    <p:sldId id="309" r:id="rId34"/>
    <p:sldId id="310" r:id="rId35"/>
    <p:sldId id="311" r:id="rId36"/>
    <p:sldId id="312" r:id="rId37"/>
    <p:sldId id="313" r:id="rId38"/>
    <p:sldId id="314" r:id="rId39"/>
    <p:sldId id="315" r:id="rId40"/>
    <p:sldId id="316" r:id="rId41"/>
    <p:sldId id="317" r:id="rId42"/>
    <p:sldId id="318" r:id="rId43"/>
    <p:sldId id="319" r:id="rId44"/>
    <p:sldId id="320" r:id="rId45"/>
    <p:sldId id="321" r:id="rId46"/>
    <p:sldId id="322" r:id="rId4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136" autoAdjust="0"/>
    <p:restoredTop sz="93950" autoAdjust="0"/>
  </p:normalViewPr>
  <p:slideViewPr>
    <p:cSldViewPr snapToGrid="0">
      <p:cViewPr>
        <p:scale>
          <a:sx n="190" d="100"/>
          <a:sy n="190" d="100"/>
        </p:scale>
        <p:origin x="792" y="32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presProps" Target="presProps.xml"/><Relationship Id="rId8" Type="http://schemas.openxmlformats.org/officeDocument/2006/relationships/slide" Target="slides/slide7.xml"/><Relationship Id="rId51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EAC85-7EB3-4CF2-83F3-404A51AA4B48}" type="datetimeFigureOut">
              <a:rPr lang="en-GB" smtClean="0"/>
              <a:pPr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88487-7FD6-468A-BE16-FD581100DDD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10648_AB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592" y="836712"/>
            <a:ext cx="7003786" cy="537321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674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10648 (A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1277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205059_Ceva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02446" y="841248"/>
            <a:ext cx="6994800" cy="525702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30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05059 (T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6769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242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241651_AB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771" y="843524"/>
            <a:ext cx="6994800" cy="525156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41651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6769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3830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241651_Ceva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769" y="843500"/>
            <a:ext cx="6994800" cy="525156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814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41651 (A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6769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717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791" cy="525156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80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47401 (A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52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55376"/>
            <a:ext cx="5486400" cy="524523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6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47401 (A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51574" y="1437994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375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6738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80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12707 (A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80837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8299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6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12707 (A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55652" y="1436540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68503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23012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8495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6628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78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23012 (G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60676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9533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5095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28018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7014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110648_Ceva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592" y="836711"/>
            <a:ext cx="6993799" cy="526720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6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10648 (A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4036" y="141277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74401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119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65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28018 (T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0580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71800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072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35165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50628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50596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4025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5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35165 (C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93859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119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58327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6540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6643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4572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762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358327 (T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0580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018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2931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429384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6540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14838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66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5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429384 (C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2628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5095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453312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1348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56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453312 (C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521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6190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80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542469 (A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41180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792" y="836712"/>
            <a:ext cx="6997805" cy="525928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653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47568 (T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3592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414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2420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65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542469 (A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9101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5095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16136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22600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31118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65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16136 (T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29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31329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6199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65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31329 (T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663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7397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653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44400 (T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603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9476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953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44400 (T: no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161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5620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54282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50628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428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79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754282 (A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663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123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6190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653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891735 (T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4605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3" y="842720"/>
            <a:ext cx="6995160" cy="525183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30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47568 (T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603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0588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891735 (T: no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161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5622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6190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974300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109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79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974300 (A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161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537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25643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976361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1516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524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798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976361 (A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161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335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0"/>
            <a:ext cx="5486400" cy="524548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35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036784</a:t>
            </a:r>
            <a:r>
              <a:rPr lang="en-GB" dirty="0"/>
              <a:t> (C)</a:t>
            </a:r>
            <a:r>
              <a:rPr lang="en-GB" dirty="0" smtClean="0"/>
              <a:t>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36540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6067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769" y="843501"/>
            <a:ext cx="5486400" cy="530023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4173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036784 </a:t>
            </a:r>
            <a:r>
              <a:rPr lang="en-GB" dirty="0"/>
              <a:t>(</a:t>
            </a:r>
            <a:r>
              <a:rPr lang="en-GB" dirty="0" smtClean="0"/>
              <a:t>C: not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3645604" y="145161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4396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164286_AB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07083" y="838733"/>
            <a:ext cx="6994800" cy="526249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70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64286 (C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556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164286_Ceva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07085" y="839293"/>
            <a:ext cx="6994800" cy="526249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65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64286 (T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9392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189504_AB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07085" y="842589"/>
            <a:ext cx="6994800" cy="525156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792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89504 (G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74084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233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189504_Cevac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768" y="843562"/>
            <a:ext cx="6994800" cy="526249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36924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189504 (A: SNP) in Cevac_1B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6769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2062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205059_AB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99770" y="842392"/>
            <a:ext cx="6994800" cy="5273422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67544" y="436022"/>
            <a:ext cx="2653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osition 205059 (T) in AB7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366769" y="1426492"/>
            <a:ext cx="72008" cy="30243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0178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381</Words>
  <Application>Microsoft Office PowerPoint</Application>
  <PresentationFormat>On-screen Show (4:3)</PresentationFormat>
  <Paragraphs>46</Paragraphs>
  <Slides>4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6</vt:i4>
      </vt:variant>
    </vt:vector>
  </HeadingPairs>
  <TitlesOfParts>
    <vt:vector size="4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oredun Research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id Longbottom</dc:creator>
  <cp:lastModifiedBy>David Longbottom</cp:lastModifiedBy>
  <cp:revision>34</cp:revision>
  <dcterms:created xsi:type="dcterms:W3CDTF">2016-09-27T16:59:54Z</dcterms:created>
  <dcterms:modified xsi:type="dcterms:W3CDTF">2016-10-04T12:49:31Z</dcterms:modified>
</cp:coreProperties>
</file>